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2537"/>
    <p:restoredTop sz="94654"/>
  </p:normalViewPr>
  <p:slideViewPr>
    <p:cSldViewPr snapToGrid="0" snapToObjects="1">
      <p:cViewPr varScale="1">
        <p:scale>
          <a:sx n="65" d="100"/>
          <a:sy n="65" d="100"/>
        </p:scale>
        <p:origin x="232" y="1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0CB7D8-CA43-1544-BD75-9EA23B8823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20F172-E37F-AD4A-877E-20BC1EC56C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9AE1FC-0439-4647-A116-0CE5321DF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A7958B-9BB1-D843-AECD-BE0E5EB38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9A574-0DB7-C147-A2C2-144AED026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242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A1D276-8005-EB4A-A10A-8108EE98A1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CA9F33-CC24-B94B-879D-17995A3410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F832BE-4B4F-F84D-A977-B760C8F7C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A70036-D339-5B48-B462-3590BB441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BA86AA-F52C-5041-9B8E-126B4C6E3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417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3165FD-A521-A34B-9E79-2BCD6D4B4E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97C762-16C0-4046-B6EF-83AABB4BC3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23AA90-63AD-D449-87AB-48219298E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1250B2-0178-3A46-82D9-7872BFC36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20F1B3-D26F-C249-BE77-82C670C10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67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06AD86-2CB8-6C44-8EE0-CB81F6B42B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21B664-44FB-8447-B30D-7A7F5AF6B1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419E6A-8E53-D24D-8AA0-1DE113163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6DFB5D-DB83-254D-BE4D-14B50BF20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8D02BF-B2AD-8F4E-88EA-DE8C83607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142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11E2D5-49DD-C447-99C2-D261A3AFB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861D73-FE97-7246-8212-0C791FBBE7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69B8AD-D62C-3448-B73C-E9294FCA5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83AE8A-1413-8548-9F47-F05202C49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CB463-56A2-B54B-A97A-CEB4D4E45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808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6F0C9-4722-2C4F-80B4-1A72ADD4FD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8A186A-B715-B348-9190-CC205E4AFC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8CD2AD-D9F1-EF43-8259-D64B7EAE06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AA2338-9DB6-004E-9273-526AAD9D9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501F9E-7AF4-304A-B8BD-0F1D68241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956028-D9DC-A745-960B-604C51CCF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829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3F3E1-A47C-B24A-9645-7DA9CB0824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A571A4-6399-AF41-B2E6-6DE194E36F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773DF2-E574-524B-985F-89C7078B69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60BADC-E997-824B-95AD-981CD3C0E8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B67B9D-9872-AC44-B907-28C496C88F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FF52598-A37C-FA44-B8B7-335BD5D27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5FC346-A737-FB47-9FE8-DAD80EA3E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8F340F-E4F1-DB4D-AA80-1B0D6A04B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028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8FB412-CB8B-884F-BEA8-873E3C20B3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AE935A-E612-4E4A-B1C1-AEC4B6C5F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DCB0BB-DCFC-8B4F-8A75-729B34C42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9E7D82-2E0D-DA4D-B691-8652AC603E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841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1112C4-4D59-3643-B330-486D14CCF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C9D039-818D-094A-B92A-09B6CAAF7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578995-16CB-9F4C-BEAA-2EC85C51C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912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DAAA5C-C337-DD4A-B84D-AF160BD977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651E95-EF84-7D42-986F-3E95995563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6FB191-6369-6C42-AFF5-5A810895F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8073CE-76FF-8048-8870-972353A53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DDD9FA-6C8D-C746-84B6-4D114F4D6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81C8C3-401D-4145-ACF1-6E5A426F5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631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A9680-5D25-2C48-8D33-E0856770BD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A3F29A6-3911-8749-B10D-6AB9DB0785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371B60-004C-6B49-A3ED-67AC7FF6B6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4EC358-D3E4-8745-BDC1-F1B1866D1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D27A4E-735F-C349-9696-1847097FE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328C1B-87A0-E143-B2C3-AAFC218F8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380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6376A0C-699E-8B41-9B33-D2BEE0BD6F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B0D86B-D4C2-8D42-A8FA-251824115A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F572BF-5D8C-CA46-8F58-65B55F2347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B780B-29BD-6248-A3CD-29746B85F0B6}" type="datetimeFigureOut">
              <a:rPr lang="en-US" smtClean="0"/>
              <a:t>12/26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48379C-9184-8843-A6CD-93050B3397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23FCF9-273F-D443-A282-888BB70DB3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AEC46D-64A4-FB45-993E-ADAE619F6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868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ABF89E-787A-A24B-AE84-607329345C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0F1EA-3BA4-B145-8217-0B2AF63885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White blood count (WBC)	4.4x1000/mm</a:t>
            </a:r>
            <a:r>
              <a:rPr lang="en-US" baseline="30000" dirty="0"/>
              <a:t>3</a:t>
            </a:r>
          </a:p>
          <a:p>
            <a:pPr marL="0" indent="0">
              <a:buNone/>
            </a:pPr>
            <a:r>
              <a:rPr lang="en-US" dirty="0"/>
              <a:t>Hemoglobin (Hgb) 			12.0 g/dL</a:t>
            </a:r>
          </a:p>
          <a:p>
            <a:pPr marL="0" indent="0">
              <a:buNone/>
            </a:pPr>
            <a:r>
              <a:rPr lang="en-US" dirty="0"/>
              <a:t>Hematocrit (</a:t>
            </a:r>
            <a:r>
              <a:rPr lang="en-US" dirty="0" err="1"/>
              <a:t>Hct</a:t>
            </a:r>
            <a:r>
              <a:rPr lang="en-US" dirty="0"/>
              <a:t>)			37.0%</a:t>
            </a:r>
          </a:p>
          <a:p>
            <a:pPr marL="0" indent="0">
              <a:buNone/>
            </a:pPr>
            <a:r>
              <a:rPr lang="en-US" dirty="0" err="1"/>
              <a:t>Platelte</a:t>
            </a:r>
            <a:r>
              <a:rPr lang="en-US" dirty="0"/>
              <a:t> (</a:t>
            </a:r>
            <a:r>
              <a:rPr lang="en-US" dirty="0" err="1"/>
              <a:t>Plt</a:t>
            </a:r>
            <a:r>
              <a:rPr lang="en-US" dirty="0"/>
              <a:t>)				33x1000/mm</a:t>
            </a:r>
            <a:r>
              <a:rPr lang="en-US" baseline="30000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529612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EAC2DA-7BC6-194F-AE51-DCB652E33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 (BM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DA0519-9FCA-A041-B0AB-EEF7A4A784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Glucose				143 g/dL</a:t>
            </a:r>
          </a:p>
          <a:p>
            <a:pPr marL="0" indent="0">
              <a:buNone/>
            </a:pPr>
            <a:r>
              <a:rPr lang="en-US" dirty="0"/>
              <a:t>Sodium				139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Chloride				108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Potassium 				4.6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		21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Blood Urea Nitrogen (BUN)	17 mg/dL</a:t>
            </a:r>
          </a:p>
          <a:p>
            <a:pPr marL="0" indent="0">
              <a:buNone/>
            </a:pPr>
            <a:r>
              <a:rPr lang="en-US" dirty="0"/>
              <a:t>Creatine (Cr)				1.1 mg/dL</a:t>
            </a:r>
          </a:p>
        </p:txBody>
      </p:sp>
    </p:spTree>
    <p:extLst>
      <p:ext uri="{BB962C8B-B14F-4D97-AF65-F5344CB8AC3E}">
        <p14:creationId xmlns:p14="http://schemas.microsoft.com/office/powerpoint/2010/main" val="13238948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1DF276-C02C-684F-9065-F336A44613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thrombin time and international normalized ratio (PT/INR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F780CE-285C-3B42-B322-7E147EAA1E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15/1.1 seconds</a:t>
            </a:r>
          </a:p>
        </p:txBody>
      </p:sp>
    </p:spTree>
    <p:extLst>
      <p:ext uri="{BB962C8B-B14F-4D97-AF65-F5344CB8AC3E}">
        <p14:creationId xmlns:p14="http://schemas.microsoft.com/office/powerpoint/2010/main" val="25796327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B0F143-7330-ED4F-809A-E3F39938C9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ctivated Partial Thromboplastin Time (</a:t>
            </a:r>
            <a:r>
              <a:rPr lang="en-US" dirty="0" err="1"/>
              <a:t>aPTT</a:t>
            </a:r>
            <a:r>
              <a:rPr lang="en-US" dirty="0"/>
              <a:t>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AE0817-21DE-DC44-9DFE-0D9F28C9EC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40 seconds</a:t>
            </a:r>
          </a:p>
        </p:txBody>
      </p:sp>
    </p:spTree>
    <p:extLst>
      <p:ext uri="{BB962C8B-B14F-4D97-AF65-F5344CB8AC3E}">
        <p14:creationId xmlns:p14="http://schemas.microsoft.com/office/powerpoint/2010/main" val="31476252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0D12F-194E-964F-999B-2184AE7089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brinoge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E0D020-97E5-174E-8D8F-AE357A2721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450 mg/dL</a:t>
            </a:r>
          </a:p>
        </p:txBody>
      </p:sp>
    </p:spTree>
    <p:extLst>
      <p:ext uri="{BB962C8B-B14F-4D97-AF65-F5344CB8AC3E}">
        <p14:creationId xmlns:p14="http://schemas.microsoft.com/office/powerpoint/2010/main" val="6252516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D54B07-916A-D248-83F9-7B820952F6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oponi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641BA8-7396-4447-8845-7CDBE68CA1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0.01 mcg/L</a:t>
            </a:r>
          </a:p>
        </p:txBody>
      </p:sp>
    </p:spTree>
    <p:extLst>
      <p:ext uri="{BB962C8B-B14F-4D97-AF65-F5344CB8AC3E}">
        <p14:creationId xmlns:p14="http://schemas.microsoft.com/office/powerpoint/2010/main" val="26557179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AAD02D-064C-EF4C-9EDA-086AF77888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ectrocardiogram (ECG)</a:t>
            </a:r>
          </a:p>
        </p:txBody>
      </p:sp>
      <p:pic>
        <p:nvPicPr>
          <p:cNvPr id="4" name="officeArt object">
            <a:extLst>
              <a:ext uri="{FF2B5EF4-FFF2-40B4-BE49-F238E27FC236}">
                <a16:creationId xmlns:a16="http://schemas.microsoft.com/office/drawing/2014/main" id="{493E0523-8E8F-8B43-AD53-5D539B3FDCEC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124200" y="2198208"/>
            <a:ext cx="5943600" cy="3007995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1666566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8065ED-DA09-6C4A-A12F-A627B94E8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uted Tomography Angiography (CTA) Chest</a:t>
            </a:r>
          </a:p>
        </p:txBody>
      </p:sp>
      <p:pic>
        <p:nvPicPr>
          <p:cNvPr id="4" name="officeArt object">
            <a:extLst>
              <a:ext uri="{FF2B5EF4-FFF2-40B4-BE49-F238E27FC236}">
                <a16:creationId xmlns:a16="http://schemas.microsoft.com/office/drawing/2014/main" id="{7B32F75F-2A6E-A74A-962F-EA3D2192E033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006850" y="1752020"/>
            <a:ext cx="4178300" cy="41783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12139764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198741-8748-C64C-9471-AB162D9252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edside Doppler/Ultrasound</a:t>
            </a:r>
          </a:p>
        </p:txBody>
      </p:sp>
      <p:pic>
        <p:nvPicPr>
          <p:cNvPr id="6" name="officeArt object" descr="Picture 6">
            <a:extLst>
              <a:ext uri="{FF2B5EF4-FFF2-40B4-BE49-F238E27FC236}">
                <a16:creationId xmlns:a16="http://schemas.microsoft.com/office/drawing/2014/main" id="{18CBD0BB-242D-2E48-BF7B-DC673FCE7C5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140200" y="1690688"/>
            <a:ext cx="3911600" cy="32893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433658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69</Words>
  <Application>Microsoft Macintosh PowerPoint</Application>
  <PresentationFormat>Widescreen</PresentationFormat>
  <Paragraphs>24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Complete Blood Count (CBC)</vt:lpstr>
      <vt:lpstr>Basic Metabolic Panel (BMP)</vt:lpstr>
      <vt:lpstr>Prothrombin time and international normalized ratio (PT/INR)</vt:lpstr>
      <vt:lpstr>Activated Partial Thromboplastin Time (aPTT)</vt:lpstr>
      <vt:lpstr>Fibrinogen</vt:lpstr>
      <vt:lpstr>Troponin</vt:lpstr>
      <vt:lpstr>Electrocardiogram (ECG)</vt:lpstr>
      <vt:lpstr>Computed Tomography Angiography (CTA) Chest</vt:lpstr>
      <vt:lpstr>Bedside Doppler/Ultrasoun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w, Cheyenne</dc:creator>
  <cp:lastModifiedBy>Low, Cheyenne</cp:lastModifiedBy>
  <cp:revision>21</cp:revision>
  <dcterms:created xsi:type="dcterms:W3CDTF">2020-12-08T22:05:50Z</dcterms:created>
  <dcterms:modified xsi:type="dcterms:W3CDTF">2020-12-27T03:07:59Z</dcterms:modified>
</cp:coreProperties>
</file>